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258" r:id="rId2"/>
    <p:sldId id="260" r:id="rId3"/>
    <p:sldId id="259" r:id="rId4"/>
  </p:sldIdLst>
  <p:sldSz cx="9144000" cy="6858000" type="screen4x3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16E82"/>
    <a:srgbClr val="EDB9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9DB84D1-D3ED-4CE5-A9B2-23FE9EBA8B05}" v="5" dt="2023-07-19T09:51:43.60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603"/>
    <p:restoredTop sz="94656"/>
  </p:normalViewPr>
  <p:slideViewPr>
    <p:cSldViewPr snapToGrid="0" snapToObjects="1">
      <p:cViewPr varScale="1">
        <p:scale>
          <a:sx n="86" d="100"/>
          <a:sy n="86" d="100"/>
        </p:scale>
        <p:origin x="90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UAN MANUEL LOZANO GIL" userId="618ed11e-cb2c-4b03-8ac9-a8cf52f924c9" providerId="ADAL" clId="{79DB84D1-D3ED-4CE5-A9B2-23FE9EBA8B05}"/>
    <pc:docChg chg="custSel addSld delSld modSld">
      <pc:chgData name="JUAN MANUEL LOZANO GIL" userId="618ed11e-cb2c-4b03-8ac9-a8cf52f924c9" providerId="ADAL" clId="{79DB84D1-D3ED-4CE5-A9B2-23FE9EBA8B05}" dt="2023-07-19T09:51:47.444" v="51" actId="1076"/>
      <pc:docMkLst>
        <pc:docMk/>
      </pc:docMkLst>
      <pc:sldChg chg="del">
        <pc:chgData name="JUAN MANUEL LOZANO GIL" userId="618ed11e-cb2c-4b03-8ac9-a8cf52f924c9" providerId="ADAL" clId="{79DB84D1-D3ED-4CE5-A9B2-23FE9EBA8B05}" dt="2023-07-19T09:50:04.101" v="0" actId="47"/>
        <pc:sldMkLst>
          <pc:docMk/>
          <pc:sldMk cId="2022411669" sldId="257"/>
        </pc:sldMkLst>
      </pc:sldChg>
      <pc:sldChg chg="addSp delSp modSp mod">
        <pc:chgData name="JUAN MANUEL LOZANO GIL" userId="618ed11e-cb2c-4b03-8ac9-a8cf52f924c9" providerId="ADAL" clId="{79DB84D1-D3ED-4CE5-A9B2-23FE9EBA8B05}" dt="2023-07-19T09:51:36.131" v="47" actId="1076"/>
        <pc:sldMkLst>
          <pc:docMk/>
          <pc:sldMk cId="301756167" sldId="258"/>
        </pc:sldMkLst>
        <pc:spChg chg="add mod">
          <ac:chgData name="JUAN MANUEL LOZANO GIL" userId="618ed11e-cb2c-4b03-8ac9-a8cf52f924c9" providerId="ADAL" clId="{79DB84D1-D3ED-4CE5-A9B2-23FE9EBA8B05}" dt="2023-07-19T09:51:36.131" v="47" actId="1076"/>
          <ac:spMkLst>
            <pc:docMk/>
            <pc:sldMk cId="301756167" sldId="258"/>
            <ac:spMk id="8" creationId="{61828227-3706-FF1F-DBF2-0338C19D7B62}"/>
          </ac:spMkLst>
        </pc:spChg>
        <pc:spChg chg="del">
          <ac:chgData name="JUAN MANUEL LOZANO GIL" userId="618ed11e-cb2c-4b03-8ac9-a8cf52f924c9" providerId="ADAL" clId="{79DB84D1-D3ED-4CE5-A9B2-23FE9EBA8B05}" dt="2023-07-19T09:50:07.076" v="3" actId="478"/>
          <ac:spMkLst>
            <pc:docMk/>
            <pc:sldMk cId="301756167" sldId="258"/>
            <ac:spMk id="28" creationId="{00000000-0000-0000-0000-000000000000}"/>
          </ac:spMkLst>
        </pc:spChg>
        <pc:spChg chg="mod">
          <ac:chgData name="JUAN MANUEL LOZANO GIL" userId="618ed11e-cb2c-4b03-8ac9-a8cf52f924c9" providerId="ADAL" clId="{79DB84D1-D3ED-4CE5-A9B2-23FE9EBA8B05}" dt="2023-07-19T09:50:49.843" v="30" actId="1076"/>
          <ac:spMkLst>
            <pc:docMk/>
            <pc:sldMk cId="301756167" sldId="258"/>
            <ac:spMk id="36" creationId="{024437EC-E7D3-4C28-8C34-005B5AFBC79D}"/>
          </ac:spMkLst>
        </pc:spChg>
        <pc:spChg chg="del">
          <ac:chgData name="JUAN MANUEL LOZANO GIL" userId="618ed11e-cb2c-4b03-8ac9-a8cf52f924c9" providerId="ADAL" clId="{79DB84D1-D3ED-4CE5-A9B2-23FE9EBA8B05}" dt="2023-07-19T09:50:06.036" v="2" actId="478"/>
          <ac:spMkLst>
            <pc:docMk/>
            <pc:sldMk cId="301756167" sldId="258"/>
            <ac:spMk id="45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16.180" v="5" actId="478"/>
          <ac:spMkLst>
            <pc:docMk/>
            <pc:sldMk cId="301756167" sldId="258"/>
            <ac:spMk id="46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14.708" v="4" actId="478"/>
          <ac:spMkLst>
            <pc:docMk/>
            <pc:sldMk cId="301756167" sldId="258"/>
            <ac:spMk id="58" creationId="{00000000-0000-0000-0000-000000000000}"/>
          </ac:spMkLst>
        </pc:spChg>
        <pc:spChg chg="mod">
          <ac:chgData name="JUAN MANUEL LOZANO GIL" userId="618ed11e-cb2c-4b03-8ac9-a8cf52f924c9" providerId="ADAL" clId="{79DB84D1-D3ED-4CE5-A9B2-23FE9EBA8B05}" dt="2023-07-19T09:51:09.724" v="45" actId="20577"/>
          <ac:spMkLst>
            <pc:docMk/>
            <pc:sldMk cId="301756167" sldId="258"/>
            <ac:spMk id="60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17.980" v="6" actId="478"/>
          <ac:spMkLst>
            <pc:docMk/>
            <pc:sldMk cId="301756167" sldId="258"/>
            <ac:spMk id="63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64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65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66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67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71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72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73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74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75" creationId="{00000000-0000-0000-0000-000000000000}"/>
          </ac:spMkLst>
        </pc:spChg>
        <pc:spChg chg="del">
          <ac:chgData name="JUAN MANUEL LOZANO GIL" userId="618ed11e-cb2c-4b03-8ac9-a8cf52f924c9" providerId="ADAL" clId="{79DB84D1-D3ED-4CE5-A9B2-23FE9EBA8B05}" dt="2023-07-19T09:50:22.936" v="7" actId="21"/>
          <ac:spMkLst>
            <pc:docMk/>
            <pc:sldMk cId="301756167" sldId="258"/>
            <ac:spMk id="76" creationId="{00000000-0000-0000-0000-000000000000}"/>
          </ac:spMkLst>
        </pc:spChg>
        <pc:grpChg chg="del">
          <ac:chgData name="JUAN MANUEL LOZANO GIL" userId="618ed11e-cb2c-4b03-8ac9-a8cf52f924c9" providerId="ADAL" clId="{79DB84D1-D3ED-4CE5-A9B2-23FE9EBA8B05}" dt="2023-07-19T09:50:29.840" v="10" actId="21"/>
          <ac:grpSpMkLst>
            <pc:docMk/>
            <pc:sldMk cId="301756167" sldId="258"/>
            <ac:grpSpMk id="7" creationId="{00000000-0000-0000-0000-000000000000}"/>
          </ac:grpSpMkLst>
        </pc:grpChg>
        <pc:picChg chg="del">
          <ac:chgData name="JUAN MANUEL LOZANO GIL" userId="618ed11e-cb2c-4b03-8ac9-a8cf52f924c9" providerId="ADAL" clId="{79DB84D1-D3ED-4CE5-A9B2-23FE9EBA8B05}" dt="2023-07-19T09:50:22.936" v="7" actId="21"/>
          <ac:picMkLst>
            <pc:docMk/>
            <pc:sldMk cId="301756167" sldId="258"/>
            <ac:picMk id="9" creationId="{00000000-0000-0000-0000-000000000000}"/>
          </ac:picMkLst>
        </pc:picChg>
        <pc:picChg chg="del">
          <ac:chgData name="JUAN MANUEL LOZANO GIL" userId="618ed11e-cb2c-4b03-8ac9-a8cf52f924c9" providerId="ADAL" clId="{79DB84D1-D3ED-4CE5-A9B2-23FE9EBA8B05}" dt="2023-07-19T09:50:22.936" v="7" actId="21"/>
          <ac:picMkLst>
            <pc:docMk/>
            <pc:sldMk cId="301756167" sldId="258"/>
            <ac:picMk id="10" creationId="{00000000-0000-0000-0000-000000000000}"/>
          </ac:picMkLst>
        </pc:picChg>
        <pc:picChg chg="del">
          <ac:chgData name="JUAN MANUEL LOZANO GIL" userId="618ed11e-cb2c-4b03-8ac9-a8cf52f924c9" providerId="ADAL" clId="{79DB84D1-D3ED-4CE5-A9B2-23FE9EBA8B05}" dt="2023-07-19T09:50:04.997" v="1" actId="478"/>
          <ac:picMkLst>
            <pc:docMk/>
            <pc:sldMk cId="301756167" sldId="258"/>
            <ac:picMk id="19" creationId="{00000000-0000-0000-0000-000000000000}"/>
          </ac:picMkLst>
        </pc:picChg>
      </pc:sldChg>
      <pc:sldChg chg="addSp delSp modSp new mod">
        <pc:chgData name="JUAN MANUEL LOZANO GIL" userId="618ed11e-cb2c-4b03-8ac9-a8cf52f924c9" providerId="ADAL" clId="{79DB84D1-D3ED-4CE5-A9B2-23FE9EBA8B05}" dt="2023-07-19T09:51:47.444" v="51" actId="1076"/>
        <pc:sldMkLst>
          <pc:docMk/>
          <pc:sldMk cId="1710521205" sldId="259"/>
        </pc:sldMkLst>
        <pc:spChg chg="del">
          <ac:chgData name="JUAN MANUEL LOZANO GIL" userId="618ed11e-cb2c-4b03-8ac9-a8cf52f924c9" providerId="ADAL" clId="{79DB84D1-D3ED-4CE5-A9B2-23FE9EBA8B05}" dt="2023-07-19T09:50:55.476" v="32" actId="478"/>
          <ac:spMkLst>
            <pc:docMk/>
            <pc:sldMk cId="1710521205" sldId="259"/>
            <ac:spMk id="2" creationId="{02FDC074-7442-4705-3CCA-234CBFD94600}"/>
          </ac:spMkLst>
        </pc:spChg>
        <pc:spChg chg="del">
          <ac:chgData name="JUAN MANUEL LOZANO GIL" userId="618ed11e-cb2c-4b03-8ac9-a8cf52f924c9" providerId="ADAL" clId="{79DB84D1-D3ED-4CE5-A9B2-23FE9EBA8B05}" dt="2023-07-19T09:50:56.797" v="33" actId="478"/>
          <ac:spMkLst>
            <pc:docMk/>
            <pc:sldMk cId="1710521205" sldId="259"/>
            <ac:spMk id="3" creationId="{840C4573-6026-E3F9-558A-652C8224739B}"/>
          </ac:spMkLst>
        </pc:spChg>
        <pc:spChg chg="add mod">
          <ac:chgData name="JUAN MANUEL LOZANO GIL" userId="618ed11e-cb2c-4b03-8ac9-a8cf52f924c9" providerId="ADAL" clId="{79DB84D1-D3ED-4CE5-A9B2-23FE9EBA8B05}" dt="2023-07-19T09:50:54.309" v="31" actId="1076"/>
          <ac:spMkLst>
            <pc:docMk/>
            <pc:sldMk cId="1710521205" sldId="259"/>
            <ac:spMk id="6" creationId="{1E1F6B9D-CD70-9735-2F43-96974DD847FB}"/>
          </ac:spMkLst>
        </pc:spChg>
        <pc:spChg chg="add mod">
          <ac:chgData name="JUAN MANUEL LOZANO GIL" userId="618ed11e-cb2c-4b03-8ac9-a8cf52f924c9" providerId="ADAL" clId="{79DB84D1-D3ED-4CE5-A9B2-23FE9EBA8B05}" dt="2023-07-19T09:51:04.549" v="43" actId="20577"/>
          <ac:spMkLst>
            <pc:docMk/>
            <pc:sldMk cId="1710521205" sldId="259"/>
            <ac:spMk id="7" creationId="{40B2E6C7-69D5-0BFC-1183-E87CFFEC27F2}"/>
          </ac:spMkLst>
        </pc:spChg>
        <pc:spChg chg="add mod">
          <ac:chgData name="JUAN MANUEL LOZANO GIL" userId="618ed11e-cb2c-4b03-8ac9-a8cf52f924c9" providerId="ADAL" clId="{79DB84D1-D3ED-4CE5-A9B2-23FE9EBA8B05}" dt="2023-07-19T09:50:54.309" v="31" actId="1076"/>
          <ac:spMkLst>
            <pc:docMk/>
            <pc:sldMk cId="1710521205" sldId="259"/>
            <ac:spMk id="8" creationId="{7139F126-7686-7123-4E8D-CEB4F0ABABD7}"/>
          </ac:spMkLst>
        </pc:spChg>
        <pc:spChg chg="add mod">
          <ac:chgData name="JUAN MANUEL LOZANO GIL" userId="618ed11e-cb2c-4b03-8ac9-a8cf52f924c9" providerId="ADAL" clId="{79DB84D1-D3ED-4CE5-A9B2-23FE9EBA8B05}" dt="2023-07-19T09:50:54.309" v="31" actId="1076"/>
          <ac:spMkLst>
            <pc:docMk/>
            <pc:sldMk cId="1710521205" sldId="259"/>
            <ac:spMk id="9" creationId="{BD889C90-6099-F044-C490-45FB504063DA}"/>
          </ac:spMkLst>
        </pc:spChg>
        <pc:spChg chg="add mod">
          <ac:chgData name="JUAN MANUEL LOZANO GIL" userId="618ed11e-cb2c-4b03-8ac9-a8cf52f924c9" providerId="ADAL" clId="{79DB84D1-D3ED-4CE5-A9B2-23FE9EBA8B05}" dt="2023-07-19T09:50:54.309" v="31" actId="1076"/>
          <ac:spMkLst>
            <pc:docMk/>
            <pc:sldMk cId="1710521205" sldId="259"/>
            <ac:spMk id="10" creationId="{801AFF1C-455D-87D6-3BB6-99CF7D5CF06F}"/>
          </ac:spMkLst>
        </pc:spChg>
        <pc:spChg chg="add mod">
          <ac:chgData name="JUAN MANUEL LOZANO GIL" userId="618ed11e-cb2c-4b03-8ac9-a8cf52f924c9" providerId="ADAL" clId="{79DB84D1-D3ED-4CE5-A9B2-23FE9EBA8B05}" dt="2023-07-19T09:50:54.309" v="31" actId="1076"/>
          <ac:spMkLst>
            <pc:docMk/>
            <pc:sldMk cId="1710521205" sldId="259"/>
            <ac:spMk id="11" creationId="{3C4EFD8F-5EE5-5DFB-D3A6-D4F547A2EC07}"/>
          </ac:spMkLst>
        </pc:spChg>
        <pc:spChg chg="add mod">
          <ac:chgData name="JUAN MANUEL LOZANO GIL" userId="618ed11e-cb2c-4b03-8ac9-a8cf52f924c9" providerId="ADAL" clId="{79DB84D1-D3ED-4CE5-A9B2-23FE9EBA8B05}" dt="2023-07-19T09:50:54.309" v="31" actId="1076"/>
          <ac:spMkLst>
            <pc:docMk/>
            <pc:sldMk cId="1710521205" sldId="259"/>
            <ac:spMk id="12" creationId="{369B045C-4397-4E56-DDBA-FAC92649D100}"/>
          </ac:spMkLst>
        </pc:spChg>
        <pc:spChg chg="add mod">
          <ac:chgData name="JUAN MANUEL LOZANO GIL" userId="618ed11e-cb2c-4b03-8ac9-a8cf52f924c9" providerId="ADAL" clId="{79DB84D1-D3ED-4CE5-A9B2-23FE9EBA8B05}" dt="2023-07-19T09:50:54.309" v="31" actId="1076"/>
          <ac:spMkLst>
            <pc:docMk/>
            <pc:sldMk cId="1710521205" sldId="259"/>
            <ac:spMk id="13" creationId="{75481FFD-AA47-7F77-26B4-37102DA56EE6}"/>
          </ac:spMkLst>
        </pc:spChg>
        <pc:spChg chg="add mod">
          <ac:chgData name="JUAN MANUEL LOZANO GIL" userId="618ed11e-cb2c-4b03-8ac9-a8cf52f924c9" providerId="ADAL" clId="{79DB84D1-D3ED-4CE5-A9B2-23FE9EBA8B05}" dt="2023-07-19T09:50:54.309" v="31" actId="1076"/>
          <ac:spMkLst>
            <pc:docMk/>
            <pc:sldMk cId="1710521205" sldId="259"/>
            <ac:spMk id="14" creationId="{06D30F81-22A5-E58D-0EEB-C8CD7F58DAC8}"/>
          </ac:spMkLst>
        </pc:spChg>
        <pc:spChg chg="add mod">
          <ac:chgData name="JUAN MANUEL LOZANO GIL" userId="618ed11e-cb2c-4b03-8ac9-a8cf52f924c9" providerId="ADAL" clId="{79DB84D1-D3ED-4CE5-A9B2-23FE9EBA8B05}" dt="2023-07-19T09:51:03.707" v="42" actId="1076"/>
          <ac:spMkLst>
            <pc:docMk/>
            <pc:sldMk cId="1710521205" sldId="259"/>
            <ac:spMk id="15" creationId="{C3A1FA44-5AB4-DA34-8050-F3D26B8AEF08}"/>
          </ac:spMkLst>
        </pc:spChg>
        <pc:spChg chg="add mod">
          <ac:chgData name="JUAN MANUEL LOZANO GIL" userId="618ed11e-cb2c-4b03-8ac9-a8cf52f924c9" providerId="ADAL" clId="{79DB84D1-D3ED-4CE5-A9B2-23FE9EBA8B05}" dt="2023-07-19T09:51:47.444" v="51" actId="1076"/>
          <ac:spMkLst>
            <pc:docMk/>
            <pc:sldMk cId="1710521205" sldId="259"/>
            <ac:spMk id="16" creationId="{8147D8DC-4C5A-F2B2-6227-C33C93F82EDA}"/>
          </ac:spMkLst>
        </pc:spChg>
        <pc:picChg chg="add mod">
          <ac:chgData name="JUAN MANUEL LOZANO GIL" userId="618ed11e-cb2c-4b03-8ac9-a8cf52f924c9" providerId="ADAL" clId="{79DB84D1-D3ED-4CE5-A9B2-23FE9EBA8B05}" dt="2023-07-19T09:50:54.309" v="31" actId="1076"/>
          <ac:picMkLst>
            <pc:docMk/>
            <pc:sldMk cId="1710521205" sldId="259"/>
            <ac:picMk id="4" creationId="{45FB7208-9B40-FE7F-69B2-9AAC01AC3779}"/>
          </ac:picMkLst>
        </pc:picChg>
        <pc:picChg chg="add mod">
          <ac:chgData name="JUAN MANUEL LOZANO GIL" userId="618ed11e-cb2c-4b03-8ac9-a8cf52f924c9" providerId="ADAL" clId="{79DB84D1-D3ED-4CE5-A9B2-23FE9EBA8B05}" dt="2023-07-19T09:50:54.309" v="31" actId="1076"/>
          <ac:picMkLst>
            <pc:docMk/>
            <pc:sldMk cId="1710521205" sldId="259"/>
            <ac:picMk id="5" creationId="{33211763-3679-17D4-5C16-ADE69298E7AE}"/>
          </ac:picMkLst>
        </pc:picChg>
      </pc:sldChg>
      <pc:sldChg chg="addSp delSp modSp new mod">
        <pc:chgData name="JUAN MANUEL LOZANO GIL" userId="618ed11e-cb2c-4b03-8ac9-a8cf52f924c9" providerId="ADAL" clId="{79DB84D1-D3ED-4CE5-A9B2-23FE9EBA8B05}" dt="2023-07-19T09:51:42.132" v="49" actId="1076"/>
        <pc:sldMkLst>
          <pc:docMk/>
          <pc:sldMk cId="762779242" sldId="260"/>
        </pc:sldMkLst>
        <pc:spChg chg="del">
          <ac:chgData name="JUAN MANUEL LOZANO GIL" userId="618ed11e-cb2c-4b03-8ac9-a8cf52f924c9" providerId="ADAL" clId="{79DB84D1-D3ED-4CE5-A9B2-23FE9EBA8B05}" dt="2023-07-19T09:50:34.500" v="13" actId="478"/>
          <ac:spMkLst>
            <pc:docMk/>
            <pc:sldMk cId="762779242" sldId="260"/>
            <ac:spMk id="2" creationId="{19A4BED1-95E2-7534-BC4F-9AF21395860B}"/>
          </ac:spMkLst>
        </pc:spChg>
        <pc:spChg chg="del">
          <ac:chgData name="JUAN MANUEL LOZANO GIL" userId="618ed11e-cb2c-4b03-8ac9-a8cf52f924c9" providerId="ADAL" clId="{79DB84D1-D3ED-4CE5-A9B2-23FE9EBA8B05}" dt="2023-07-19T09:50:35.267" v="14" actId="478"/>
          <ac:spMkLst>
            <pc:docMk/>
            <pc:sldMk cId="762779242" sldId="260"/>
            <ac:spMk id="3" creationId="{E812E7BF-F11E-EE0C-D1E5-CB700C59BBEB}"/>
          </ac:spMkLst>
        </pc:spChg>
        <pc:spChg chg="mod">
          <ac:chgData name="JUAN MANUEL LOZANO GIL" userId="618ed11e-cb2c-4b03-8ac9-a8cf52f924c9" providerId="ADAL" clId="{79DB84D1-D3ED-4CE5-A9B2-23FE9EBA8B05}" dt="2023-07-19T09:50:32.874" v="12"/>
          <ac:spMkLst>
            <pc:docMk/>
            <pc:sldMk cId="762779242" sldId="260"/>
            <ac:spMk id="8" creationId="{F62F7BDF-9647-C386-8F4F-43C38B6B74EB}"/>
          </ac:spMkLst>
        </pc:spChg>
        <pc:spChg chg="mod">
          <ac:chgData name="JUAN MANUEL LOZANO GIL" userId="618ed11e-cb2c-4b03-8ac9-a8cf52f924c9" providerId="ADAL" clId="{79DB84D1-D3ED-4CE5-A9B2-23FE9EBA8B05}" dt="2023-07-19T09:51:07.468" v="44" actId="20577"/>
          <ac:spMkLst>
            <pc:docMk/>
            <pc:sldMk cId="762779242" sldId="260"/>
            <ac:spMk id="9" creationId="{7D713267-C6E3-2679-D6AE-16F2C396047F}"/>
          </ac:spMkLst>
        </pc:spChg>
        <pc:spChg chg="mod">
          <ac:chgData name="JUAN MANUEL LOZANO GIL" userId="618ed11e-cb2c-4b03-8ac9-a8cf52f924c9" providerId="ADAL" clId="{79DB84D1-D3ED-4CE5-A9B2-23FE9EBA8B05}" dt="2023-07-19T09:50:32.874" v="12"/>
          <ac:spMkLst>
            <pc:docMk/>
            <pc:sldMk cId="762779242" sldId="260"/>
            <ac:spMk id="10" creationId="{13B1E4A4-DB0D-5B2B-C24B-CBDB7476B17E}"/>
          </ac:spMkLst>
        </pc:spChg>
        <pc:spChg chg="mod">
          <ac:chgData name="JUAN MANUEL LOZANO GIL" userId="618ed11e-cb2c-4b03-8ac9-a8cf52f924c9" providerId="ADAL" clId="{79DB84D1-D3ED-4CE5-A9B2-23FE9EBA8B05}" dt="2023-07-19T09:50:32.874" v="12"/>
          <ac:spMkLst>
            <pc:docMk/>
            <pc:sldMk cId="762779242" sldId="260"/>
            <ac:spMk id="11" creationId="{F0185F5E-E877-53D3-A1F1-FC0B42BE1CD2}"/>
          </ac:spMkLst>
        </pc:spChg>
        <pc:spChg chg="mod">
          <ac:chgData name="JUAN MANUEL LOZANO GIL" userId="618ed11e-cb2c-4b03-8ac9-a8cf52f924c9" providerId="ADAL" clId="{79DB84D1-D3ED-4CE5-A9B2-23FE9EBA8B05}" dt="2023-07-19T09:50:32.874" v="12"/>
          <ac:spMkLst>
            <pc:docMk/>
            <pc:sldMk cId="762779242" sldId="260"/>
            <ac:spMk id="12" creationId="{62AAE0C8-815E-D22B-F1ED-1FF27FF0A699}"/>
          </ac:spMkLst>
        </pc:spChg>
        <pc:spChg chg="mod">
          <ac:chgData name="JUAN MANUEL LOZANO GIL" userId="618ed11e-cb2c-4b03-8ac9-a8cf52f924c9" providerId="ADAL" clId="{79DB84D1-D3ED-4CE5-A9B2-23FE9EBA8B05}" dt="2023-07-19T09:50:32.874" v="12"/>
          <ac:spMkLst>
            <pc:docMk/>
            <pc:sldMk cId="762779242" sldId="260"/>
            <ac:spMk id="13" creationId="{BD92DB75-7EDF-9C75-1D81-B34ADA528BF4}"/>
          </ac:spMkLst>
        </pc:spChg>
        <pc:spChg chg="mod">
          <ac:chgData name="JUAN MANUEL LOZANO GIL" userId="618ed11e-cb2c-4b03-8ac9-a8cf52f924c9" providerId="ADAL" clId="{79DB84D1-D3ED-4CE5-A9B2-23FE9EBA8B05}" dt="2023-07-19T09:50:32.874" v="12"/>
          <ac:spMkLst>
            <pc:docMk/>
            <pc:sldMk cId="762779242" sldId="260"/>
            <ac:spMk id="14" creationId="{19D17294-921B-3F28-C6DC-7CBCC42FCA96}"/>
          </ac:spMkLst>
        </pc:spChg>
        <pc:spChg chg="mod">
          <ac:chgData name="JUAN MANUEL LOZANO GIL" userId="618ed11e-cb2c-4b03-8ac9-a8cf52f924c9" providerId="ADAL" clId="{79DB84D1-D3ED-4CE5-A9B2-23FE9EBA8B05}" dt="2023-07-19T09:50:32.874" v="12"/>
          <ac:spMkLst>
            <pc:docMk/>
            <pc:sldMk cId="762779242" sldId="260"/>
            <ac:spMk id="15" creationId="{17393FC0-0DA0-2DD1-971A-C1F399B8830B}"/>
          </ac:spMkLst>
        </pc:spChg>
        <pc:spChg chg="mod">
          <ac:chgData name="JUAN MANUEL LOZANO GIL" userId="618ed11e-cb2c-4b03-8ac9-a8cf52f924c9" providerId="ADAL" clId="{79DB84D1-D3ED-4CE5-A9B2-23FE9EBA8B05}" dt="2023-07-19T09:50:32.874" v="12"/>
          <ac:spMkLst>
            <pc:docMk/>
            <pc:sldMk cId="762779242" sldId="260"/>
            <ac:spMk id="16" creationId="{9D1A6F9F-05CE-68E0-2570-EBB14900009E}"/>
          </ac:spMkLst>
        </pc:spChg>
        <pc:spChg chg="mod">
          <ac:chgData name="JUAN MANUEL LOZANO GIL" userId="618ed11e-cb2c-4b03-8ac9-a8cf52f924c9" providerId="ADAL" clId="{79DB84D1-D3ED-4CE5-A9B2-23FE9EBA8B05}" dt="2023-07-19T09:50:42.045" v="22" actId="20577"/>
          <ac:spMkLst>
            <pc:docMk/>
            <pc:sldMk cId="762779242" sldId="260"/>
            <ac:spMk id="17" creationId="{0435A58E-B10F-C069-70F7-C436B93D1D84}"/>
          </ac:spMkLst>
        </pc:spChg>
        <pc:spChg chg="add mod">
          <ac:chgData name="JUAN MANUEL LOZANO GIL" userId="618ed11e-cb2c-4b03-8ac9-a8cf52f924c9" providerId="ADAL" clId="{79DB84D1-D3ED-4CE5-A9B2-23FE9EBA8B05}" dt="2023-07-19T09:51:42.132" v="49" actId="1076"/>
          <ac:spMkLst>
            <pc:docMk/>
            <pc:sldMk cId="762779242" sldId="260"/>
            <ac:spMk id="18" creationId="{065D67CC-B73D-B1D7-886C-58B3F3DDDB04}"/>
          </ac:spMkLst>
        </pc:spChg>
        <pc:grpChg chg="add mod">
          <ac:chgData name="JUAN MANUEL LOZANO GIL" userId="618ed11e-cb2c-4b03-8ac9-a8cf52f924c9" providerId="ADAL" clId="{79DB84D1-D3ED-4CE5-A9B2-23FE9EBA8B05}" dt="2023-07-19T09:50:32.874" v="12"/>
          <ac:grpSpMkLst>
            <pc:docMk/>
            <pc:sldMk cId="762779242" sldId="260"/>
            <ac:grpSpMk id="4" creationId="{786686AA-98AB-A46F-C92B-C3CF5DC6755A}"/>
          </ac:grpSpMkLst>
        </pc:grpChg>
        <pc:grpChg chg="mod">
          <ac:chgData name="JUAN MANUEL LOZANO GIL" userId="618ed11e-cb2c-4b03-8ac9-a8cf52f924c9" providerId="ADAL" clId="{79DB84D1-D3ED-4CE5-A9B2-23FE9EBA8B05}" dt="2023-07-19T09:50:32.874" v="12"/>
          <ac:grpSpMkLst>
            <pc:docMk/>
            <pc:sldMk cId="762779242" sldId="260"/>
            <ac:grpSpMk id="5" creationId="{1365B62F-5D5F-59D8-205A-8E76AFD7F429}"/>
          </ac:grpSpMkLst>
        </pc:grpChg>
        <pc:picChg chg="mod">
          <ac:chgData name="JUAN MANUEL LOZANO GIL" userId="618ed11e-cb2c-4b03-8ac9-a8cf52f924c9" providerId="ADAL" clId="{79DB84D1-D3ED-4CE5-A9B2-23FE9EBA8B05}" dt="2023-07-19T09:50:32.874" v="12"/>
          <ac:picMkLst>
            <pc:docMk/>
            <pc:sldMk cId="762779242" sldId="260"/>
            <ac:picMk id="6" creationId="{84836211-D43E-BE30-D6D8-D374F8B22C1C}"/>
          </ac:picMkLst>
        </pc:picChg>
        <pc:picChg chg="mod">
          <ac:chgData name="JUAN MANUEL LOZANO GIL" userId="618ed11e-cb2c-4b03-8ac9-a8cf52f924c9" providerId="ADAL" clId="{79DB84D1-D3ED-4CE5-A9B2-23FE9EBA8B05}" dt="2023-07-19T09:50:32.874" v="12"/>
          <ac:picMkLst>
            <pc:docMk/>
            <pc:sldMk cId="762779242" sldId="260"/>
            <ac:picMk id="7" creationId="{BA7E2C23-A214-C20F-2E7C-296E93B05049}"/>
          </ac:picMkLst>
        </pc:picChg>
      </pc:sldChg>
    </pc:docChg>
  </pc:docChgLst>
  <pc:docChgLst>
    <pc:chgData name="juanmanuel.lozanog@um.es" userId="618ed11e-cb2c-4b03-8ac9-a8cf52f924c9" providerId="ADAL" clId="{3333E839-D124-48EC-B15A-828897AF11B6}"/>
    <pc:docChg chg="undo custSel addSld delSld modSld">
      <pc:chgData name="juanmanuel.lozanog@um.es" userId="618ed11e-cb2c-4b03-8ac9-a8cf52f924c9" providerId="ADAL" clId="{3333E839-D124-48EC-B15A-828897AF11B6}" dt="2021-10-22T08:20:41.093" v="269" actId="1076"/>
      <pc:docMkLst>
        <pc:docMk/>
      </pc:docMkLst>
      <pc:sldChg chg="modSp mod">
        <pc:chgData name="juanmanuel.lozanog@um.es" userId="618ed11e-cb2c-4b03-8ac9-a8cf52f924c9" providerId="ADAL" clId="{3333E839-D124-48EC-B15A-828897AF11B6}" dt="2021-10-22T08:02:46.942" v="1" actId="1076"/>
        <pc:sldMkLst>
          <pc:docMk/>
          <pc:sldMk cId="2022411669" sldId="257"/>
        </pc:sldMkLst>
        <pc:spChg chg="mod">
          <ac:chgData name="juanmanuel.lozanog@um.es" userId="618ed11e-cb2c-4b03-8ac9-a8cf52f924c9" providerId="ADAL" clId="{3333E839-D124-48EC-B15A-828897AF11B6}" dt="2021-10-22T08:02:46.942" v="1" actId="1076"/>
          <ac:spMkLst>
            <pc:docMk/>
            <pc:sldMk cId="2022411669" sldId="257"/>
            <ac:spMk id="7" creationId="{00000000-0000-0000-0000-000000000000}"/>
          </ac:spMkLst>
        </pc:spChg>
      </pc:sldChg>
      <pc:sldChg chg="addSp delSp modSp mod">
        <pc:chgData name="juanmanuel.lozanog@um.es" userId="618ed11e-cb2c-4b03-8ac9-a8cf52f924c9" providerId="ADAL" clId="{3333E839-D124-48EC-B15A-828897AF11B6}" dt="2021-10-22T08:09:56.503" v="183" actId="1076"/>
        <pc:sldMkLst>
          <pc:docMk/>
          <pc:sldMk cId="301756167" sldId="258"/>
        </pc:sldMkLst>
        <pc:spChg chg="add del 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8" creationId="{00000000-0000-0000-0000-000000000000}"/>
          </ac:spMkLst>
        </pc:spChg>
        <pc:spChg chg="del">
          <ac:chgData name="juanmanuel.lozanog@um.es" userId="618ed11e-cb2c-4b03-8ac9-a8cf52f924c9" providerId="ADAL" clId="{3333E839-D124-48EC-B15A-828897AF11B6}" dt="2021-10-22T08:06:33.431" v="75" actId="478"/>
          <ac:spMkLst>
            <pc:docMk/>
            <pc:sldMk cId="301756167" sldId="258"/>
            <ac:spMk id="10" creationId="{00000000-0000-0000-0000-000000000000}"/>
          </ac:spMkLst>
        </pc:spChg>
        <pc:spChg chg="add del">
          <ac:chgData name="juanmanuel.lozanog@um.es" userId="618ed11e-cb2c-4b03-8ac9-a8cf52f924c9" providerId="ADAL" clId="{3333E839-D124-48EC-B15A-828897AF11B6}" dt="2021-10-22T08:03:21.296" v="26" actId="478"/>
          <ac:spMkLst>
            <pc:docMk/>
            <pc:sldMk cId="301756167" sldId="258"/>
            <ac:spMk id="15" creationId="{00000000-0000-0000-0000-000000000000}"/>
          </ac:spMkLst>
        </pc:spChg>
        <pc:spChg chg="del">
          <ac:chgData name="juanmanuel.lozanog@um.es" userId="618ed11e-cb2c-4b03-8ac9-a8cf52f924c9" providerId="ADAL" clId="{3333E839-D124-48EC-B15A-828897AF11B6}" dt="2021-10-22T08:06:15.793" v="71" actId="478"/>
          <ac:spMkLst>
            <pc:docMk/>
            <pc:sldMk cId="301756167" sldId="258"/>
            <ac:spMk id="16" creationId="{00000000-0000-0000-0000-000000000000}"/>
          </ac:spMkLst>
        </pc:spChg>
        <pc:spChg chg="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17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26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27" creationId="{00000000-0000-0000-0000-000000000000}"/>
          </ac:spMkLst>
        </pc:spChg>
        <pc:spChg chg="add del">
          <ac:chgData name="juanmanuel.lozanog@um.es" userId="618ed11e-cb2c-4b03-8ac9-a8cf52f924c9" providerId="ADAL" clId="{3333E839-D124-48EC-B15A-828897AF11B6}" dt="2021-10-22T08:03:10.969" v="24" actId="478"/>
          <ac:spMkLst>
            <pc:docMk/>
            <pc:sldMk cId="301756167" sldId="258"/>
            <ac:spMk id="28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29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30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31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32" creationId="{00000000-0000-0000-0000-000000000000}"/>
          </ac:spMkLst>
        </pc:spChg>
        <pc:spChg chg="add del">
          <ac:chgData name="juanmanuel.lozanog@um.es" userId="618ed11e-cb2c-4b03-8ac9-a8cf52f924c9" providerId="ADAL" clId="{3333E839-D124-48EC-B15A-828897AF11B6}" dt="2021-10-22T08:06:33.431" v="75" actId="478"/>
          <ac:spMkLst>
            <pc:docMk/>
            <pc:sldMk cId="301756167" sldId="258"/>
            <ac:spMk id="33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34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52.175" v="182" actId="164"/>
          <ac:spMkLst>
            <pc:docMk/>
            <pc:sldMk cId="301756167" sldId="258"/>
            <ac:spMk id="35" creationId="{00000000-0000-0000-0000-000000000000}"/>
          </ac:spMkLst>
        </pc:spChg>
        <pc:spChg chg="add del">
          <ac:chgData name="juanmanuel.lozanog@um.es" userId="618ed11e-cb2c-4b03-8ac9-a8cf52f924c9" providerId="ADAL" clId="{3333E839-D124-48EC-B15A-828897AF11B6}" dt="2021-10-22T08:06:33.431" v="75" actId="478"/>
          <ac:spMkLst>
            <pc:docMk/>
            <pc:sldMk cId="301756167" sldId="258"/>
            <ac:spMk id="36" creationId="{00000000-0000-0000-0000-000000000000}"/>
          </ac:spMkLst>
        </pc:spChg>
        <pc:spChg chg="add del">
          <ac:chgData name="juanmanuel.lozanog@um.es" userId="618ed11e-cb2c-4b03-8ac9-a8cf52f924c9" providerId="ADAL" clId="{3333E839-D124-48EC-B15A-828897AF11B6}" dt="2021-10-22T08:06:33.431" v="75" actId="478"/>
          <ac:spMkLst>
            <pc:docMk/>
            <pc:sldMk cId="301756167" sldId="258"/>
            <ac:spMk id="37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38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40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41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42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43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44" creationId="{00000000-0000-0000-0000-000000000000}"/>
          </ac:spMkLst>
        </pc:spChg>
        <pc:spChg chg="mod">
          <ac:chgData name="juanmanuel.lozanog@um.es" userId="618ed11e-cb2c-4b03-8ac9-a8cf52f924c9" providerId="ADAL" clId="{3333E839-D124-48EC-B15A-828897AF11B6}" dt="2021-10-22T08:09:36.475" v="178" actId="20577"/>
          <ac:spMkLst>
            <pc:docMk/>
            <pc:sldMk cId="301756167" sldId="258"/>
            <ac:spMk id="45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46" creationId="{00000000-0000-0000-0000-000000000000}"/>
          </ac:spMkLst>
        </pc:spChg>
        <pc:spChg chg="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48" creationId="{00000000-0000-0000-0000-000000000000}"/>
          </ac:spMkLst>
        </pc:spChg>
        <pc:spChg chg="del">
          <ac:chgData name="juanmanuel.lozanog@um.es" userId="618ed11e-cb2c-4b03-8ac9-a8cf52f924c9" providerId="ADAL" clId="{3333E839-D124-48EC-B15A-828897AF11B6}" dt="2021-10-22T08:06:33.431" v="75" actId="478"/>
          <ac:spMkLst>
            <pc:docMk/>
            <pc:sldMk cId="301756167" sldId="258"/>
            <ac:spMk id="49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44.755" v="179" actId="164"/>
          <ac:spMkLst>
            <pc:docMk/>
            <pc:sldMk cId="301756167" sldId="258"/>
            <ac:spMk id="51" creationId="{00000000-0000-0000-0000-000000000000}"/>
          </ac:spMkLst>
        </pc:spChg>
        <pc:spChg chg="add del">
          <ac:chgData name="juanmanuel.lozanog@um.es" userId="618ed11e-cb2c-4b03-8ac9-a8cf52f924c9" providerId="ADAL" clId="{3333E839-D124-48EC-B15A-828897AF11B6}" dt="2021-10-22T08:03:18.984" v="25" actId="478"/>
          <ac:spMkLst>
            <pc:docMk/>
            <pc:sldMk cId="301756167" sldId="258"/>
            <ac:spMk id="52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68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69" creationId="{00000000-0000-0000-0000-000000000000}"/>
          </ac:spMkLst>
        </pc:spChg>
        <pc:spChg chg="add del mod">
          <ac:chgData name="juanmanuel.lozanog@um.es" userId="618ed11e-cb2c-4b03-8ac9-a8cf52f924c9" providerId="ADAL" clId="{3333E839-D124-48EC-B15A-828897AF11B6}" dt="2021-10-22T08:09:29.195" v="169" actId="164"/>
          <ac:spMkLst>
            <pc:docMk/>
            <pc:sldMk cId="301756167" sldId="258"/>
            <ac:spMk id="70" creationId="{00000000-0000-0000-0000-000000000000}"/>
          </ac:spMkLst>
        </pc:spChg>
        <pc:grpChg chg="add mod">
          <ac:chgData name="juanmanuel.lozanog@um.es" userId="618ed11e-cb2c-4b03-8ac9-a8cf52f924c9" providerId="ADAL" clId="{3333E839-D124-48EC-B15A-828897AF11B6}" dt="2021-10-22T08:09:32.132" v="170" actId="1076"/>
          <ac:grpSpMkLst>
            <pc:docMk/>
            <pc:sldMk cId="301756167" sldId="258"/>
            <ac:grpSpMk id="25" creationId="{6ED0DA7D-5BDF-4004-8DED-F89FE6122690}"/>
          </ac:grpSpMkLst>
        </pc:grpChg>
        <pc:grpChg chg="add mod">
          <ac:chgData name="juanmanuel.lozanog@um.es" userId="618ed11e-cb2c-4b03-8ac9-a8cf52f924c9" providerId="ADAL" clId="{3333E839-D124-48EC-B15A-828897AF11B6}" dt="2021-10-22T08:09:52.175" v="182" actId="164"/>
          <ac:grpSpMkLst>
            <pc:docMk/>
            <pc:sldMk cId="301756167" sldId="258"/>
            <ac:grpSpMk id="53" creationId="{EC8F92F4-B53B-4BD2-910B-9AC1D666B977}"/>
          </ac:grpSpMkLst>
        </pc:grpChg>
        <pc:grpChg chg="add mod">
          <ac:chgData name="juanmanuel.lozanog@um.es" userId="618ed11e-cb2c-4b03-8ac9-a8cf52f924c9" providerId="ADAL" clId="{3333E839-D124-48EC-B15A-828897AF11B6}" dt="2021-10-22T08:09:56.503" v="183" actId="1076"/>
          <ac:grpSpMkLst>
            <pc:docMk/>
            <pc:sldMk cId="301756167" sldId="258"/>
            <ac:grpSpMk id="54" creationId="{845EE6F5-DE17-4D3C-B6A8-1DA03845F472}"/>
          </ac:grpSpMkLst>
        </pc:grpChg>
        <pc:picChg chg="add del mod">
          <ac:chgData name="juanmanuel.lozanog@um.es" userId="618ed11e-cb2c-4b03-8ac9-a8cf52f924c9" providerId="ADAL" clId="{3333E839-D124-48EC-B15A-828897AF11B6}" dt="2021-10-22T08:03:52.992" v="32" actId="478"/>
          <ac:picMkLst>
            <pc:docMk/>
            <pc:sldMk cId="301756167" sldId="258"/>
            <ac:picMk id="3" creationId="{46061F44-5953-4C47-BBE2-4A01539C4A3E}"/>
          </ac:picMkLst>
        </pc:picChg>
        <pc:picChg chg="add del">
          <ac:chgData name="juanmanuel.lozanog@um.es" userId="618ed11e-cb2c-4b03-8ac9-a8cf52f924c9" providerId="ADAL" clId="{3333E839-D124-48EC-B15A-828897AF11B6}" dt="2021-10-22T08:03:18.984" v="25" actId="478"/>
          <ac:picMkLst>
            <pc:docMk/>
            <pc:sldMk cId="301756167" sldId="258"/>
            <ac:picMk id="4" creationId="{00000000-0000-0000-0000-000000000000}"/>
          </ac:picMkLst>
        </pc:picChg>
        <pc:picChg chg="add del">
          <ac:chgData name="juanmanuel.lozanog@um.es" userId="618ed11e-cb2c-4b03-8ac9-a8cf52f924c9" providerId="ADAL" clId="{3333E839-D124-48EC-B15A-828897AF11B6}" dt="2021-10-22T08:03:18.984" v="25" actId="478"/>
          <ac:picMkLst>
            <pc:docMk/>
            <pc:sldMk cId="301756167" sldId="258"/>
            <ac:picMk id="6" creationId="{00000000-0000-0000-0000-000000000000}"/>
          </ac:picMkLst>
        </pc:picChg>
        <pc:picChg chg="add del">
          <ac:chgData name="juanmanuel.lozanog@um.es" userId="618ed11e-cb2c-4b03-8ac9-a8cf52f924c9" providerId="ADAL" clId="{3333E839-D124-48EC-B15A-828897AF11B6}" dt="2021-10-22T08:03:18.984" v="25" actId="478"/>
          <ac:picMkLst>
            <pc:docMk/>
            <pc:sldMk cId="301756167" sldId="258"/>
            <ac:picMk id="7" creationId="{00000000-0000-0000-0000-000000000000}"/>
          </ac:picMkLst>
        </pc:picChg>
        <pc:picChg chg="add del mod">
          <ac:chgData name="juanmanuel.lozanog@um.es" userId="618ed11e-cb2c-4b03-8ac9-a8cf52f924c9" providerId="ADAL" clId="{3333E839-D124-48EC-B15A-828897AF11B6}" dt="2021-10-22T08:04:09.988" v="37" actId="478"/>
          <ac:picMkLst>
            <pc:docMk/>
            <pc:sldMk cId="301756167" sldId="258"/>
            <ac:picMk id="9" creationId="{AD6A45B0-ABBD-4937-BD37-C90A14497CD8}"/>
          </ac:picMkLst>
        </pc:picChg>
        <pc:picChg chg="add del">
          <ac:chgData name="juanmanuel.lozanog@um.es" userId="618ed11e-cb2c-4b03-8ac9-a8cf52f924c9" providerId="ADAL" clId="{3333E839-D124-48EC-B15A-828897AF11B6}" dt="2021-10-22T08:03:18.984" v="25" actId="478"/>
          <ac:picMkLst>
            <pc:docMk/>
            <pc:sldMk cId="301756167" sldId="258"/>
            <ac:picMk id="11" creationId="{00000000-0000-0000-0000-000000000000}"/>
          </ac:picMkLst>
        </pc:picChg>
        <pc:picChg chg="add mod modCrop">
          <ac:chgData name="juanmanuel.lozanog@um.es" userId="618ed11e-cb2c-4b03-8ac9-a8cf52f924c9" providerId="ADAL" clId="{3333E839-D124-48EC-B15A-828897AF11B6}" dt="2021-10-22T08:09:29.195" v="169" actId="164"/>
          <ac:picMkLst>
            <pc:docMk/>
            <pc:sldMk cId="301756167" sldId="258"/>
            <ac:picMk id="13" creationId="{DB8E88D5-8447-4D32-BF8E-150AD87F0332}"/>
          </ac:picMkLst>
        </pc:picChg>
        <pc:picChg chg="add del">
          <ac:chgData name="juanmanuel.lozanog@um.es" userId="618ed11e-cb2c-4b03-8ac9-a8cf52f924c9" providerId="ADAL" clId="{3333E839-D124-48EC-B15A-828897AF11B6}" dt="2021-10-22T08:03:18.984" v="25" actId="478"/>
          <ac:picMkLst>
            <pc:docMk/>
            <pc:sldMk cId="301756167" sldId="258"/>
            <ac:picMk id="14" creationId="{00000000-0000-0000-0000-000000000000}"/>
          </ac:picMkLst>
        </pc:picChg>
        <pc:picChg chg="add mod modCrop">
          <ac:chgData name="juanmanuel.lozanog@um.es" userId="618ed11e-cb2c-4b03-8ac9-a8cf52f924c9" providerId="ADAL" clId="{3333E839-D124-48EC-B15A-828897AF11B6}" dt="2021-10-22T08:09:29.195" v="169" actId="164"/>
          <ac:picMkLst>
            <pc:docMk/>
            <pc:sldMk cId="301756167" sldId="258"/>
            <ac:picMk id="20" creationId="{0C5B36B1-1D10-4E3D-925F-E988B26B4120}"/>
          </ac:picMkLst>
        </pc:picChg>
        <pc:picChg chg="add mod modCrop">
          <ac:chgData name="juanmanuel.lozanog@um.es" userId="618ed11e-cb2c-4b03-8ac9-a8cf52f924c9" providerId="ADAL" clId="{3333E839-D124-48EC-B15A-828897AF11B6}" dt="2021-10-22T08:09:44.755" v="179" actId="164"/>
          <ac:picMkLst>
            <pc:docMk/>
            <pc:sldMk cId="301756167" sldId="258"/>
            <ac:picMk id="22" creationId="{C76D44F0-4954-4CD4-B398-2636551F6F67}"/>
          </ac:picMkLst>
        </pc:picChg>
        <pc:picChg chg="add mod modCrop">
          <ac:chgData name="juanmanuel.lozanog@um.es" userId="618ed11e-cb2c-4b03-8ac9-a8cf52f924c9" providerId="ADAL" clId="{3333E839-D124-48EC-B15A-828897AF11B6}" dt="2021-10-22T08:09:44.755" v="179" actId="164"/>
          <ac:picMkLst>
            <pc:docMk/>
            <pc:sldMk cId="301756167" sldId="258"/>
            <ac:picMk id="24" creationId="{EE06E885-0E3A-4AC3-A8B1-5E16D228F4B9}"/>
          </ac:picMkLst>
        </pc:picChg>
        <pc:picChg chg="add del">
          <ac:chgData name="juanmanuel.lozanog@um.es" userId="618ed11e-cb2c-4b03-8ac9-a8cf52f924c9" providerId="ADAL" clId="{3333E839-D124-48EC-B15A-828897AF11B6}" dt="2021-10-22T08:06:27.401" v="74" actId="478"/>
          <ac:picMkLst>
            <pc:docMk/>
            <pc:sldMk cId="301756167" sldId="258"/>
            <ac:picMk id="39" creationId="{00000000-0000-0000-0000-000000000000}"/>
          </ac:picMkLst>
        </pc:picChg>
      </pc:sldChg>
      <pc:sldChg chg="addSp delSp modSp add mod">
        <pc:chgData name="juanmanuel.lozanog@um.es" userId="618ed11e-cb2c-4b03-8ac9-a8cf52f924c9" providerId="ADAL" clId="{3333E839-D124-48EC-B15A-828897AF11B6}" dt="2021-10-22T08:20:41.093" v="269" actId="1076"/>
        <pc:sldMkLst>
          <pc:docMk/>
          <pc:sldMk cId="345643746" sldId="259"/>
        </pc:sldMkLst>
        <pc:spChg chg="mod topLvl">
          <ac:chgData name="juanmanuel.lozanog@um.es" userId="618ed11e-cb2c-4b03-8ac9-a8cf52f924c9" providerId="ADAL" clId="{3333E839-D124-48EC-B15A-828897AF11B6}" dt="2021-10-22T08:17:33.372" v="229" actId="164"/>
          <ac:spMkLst>
            <pc:docMk/>
            <pc:sldMk cId="345643746" sldId="259"/>
            <ac:spMk id="8" creationId="{00000000-0000-0000-0000-000000000000}"/>
          </ac:spMkLst>
        </pc:spChg>
        <pc:spChg chg="del mod topLvl">
          <ac:chgData name="juanmanuel.lozanog@um.es" userId="618ed11e-cb2c-4b03-8ac9-a8cf52f924c9" providerId="ADAL" clId="{3333E839-D124-48EC-B15A-828897AF11B6}" dt="2021-10-22T08:17:37.965" v="231" actId="478"/>
          <ac:spMkLst>
            <pc:docMk/>
            <pc:sldMk cId="345643746" sldId="259"/>
            <ac:spMk id="17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8:18.442" v="234" actId="1076"/>
          <ac:spMkLst>
            <pc:docMk/>
            <pc:sldMk cId="345643746" sldId="259"/>
            <ac:spMk id="26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8:23.019" v="235" actId="1076"/>
          <ac:spMkLst>
            <pc:docMk/>
            <pc:sldMk cId="345643746" sldId="259"/>
            <ac:spMk id="27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8:26.800" v="236" actId="1076"/>
          <ac:spMkLst>
            <pc:docMk/>
            <pc:sldMk cId="345643746" sldId="259"/>
            <ac:spMk id="29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8:30.002" v="237" actId="1076"/>
          <ac:spMkLst>
            <pc:docMk/>
            <pc:sldMk cId="345643746" sldId="259"/>
            <ac:spMk id="30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8:34.501" v="238" actId="1076"/>
          <ac:spMkLst>
            <pc:docMk/>
            <pc:sldMk cId="345643746" sldId="259"/>
            <ac:spMk id="31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8:37.688" v="239" actId="1076"/>
          <ac:spMkLst>
            <pc:docMk/>
            <pc:sldMk cId="345643746" sldId="259"/>
            <ac:spMk id="32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7:33.372" v="229" actId="164"/>
          <ac:spMkLst>
            <pc:docMk/>
            <pc:sldMk cId="345643746" sldId="259"/>
            <ac:spMk id="34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7:33.372" v="229" actId="164"/>
          <ac:spMkLst>
            <pc:docMk/>
            <pc:sldMk cId="345643746" sldId="259"/>
            <ac:spMk id="35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9:41.191" v="257" actId="1076"/>
          <ac:spMkLst>
            <pc:docMk/>
            <pc:sldMk cId="345643746" sldId="259"/>
            <ac:spMk id="38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20:06.997" v="264" actId="1076"/>
          <ac:spMkLst>
            <pc:docMk/>
            <pc:sldMk cId="345643746" sldId="259"/>
            <ac:spMk id="40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9:49.048" v="259" actId="1076"/>
          <ac:spMkLst>
            <pc:docMk/>
            <pc:sldMk cId="345643746" sldId="259"/>
            <ac:spMk id="41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20:03.233" v="263" actId="1076"/>
          <ac:spMkLst>
            <pc:docMk/>
            <pc:sldMk cId="345643746" sldId="259"/>
            <ac:spMk id="42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20:12.574" v="265" actId="1076"/>
          <ac:spMkLst>
            <pc:docMk/>
            <pc:sldMk cId="345643746" sldId="259"/>
            <ac:spMk id="43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20:15.183" v="266" actId="1076"/>
          <ac:spMkLst>
            <pc:docMk/>
            <pc:sldMk cId="345643746" sldId="259"/>
            <ac:spMk id="44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9:37.754" v="256" actId="1076"/>
          <ac:spMkLst>
            <pc:docMk/>
            <pc:sldMk cId="345643746" sldId="259"/>
            <ac:spMk id="46" creationId="{00000000-0000-0000-0000-000000000000}"/>
          </ac:spMkLst>
        </pc:spChg>
        <pc:spChg chg="del mod topLvl">
          <ac:chgData name="juanmanuel.lozanog@um.es" userId="618ed11e-cb2c-4b03-8ac9-a8cf52f924c9" providerId="ADAL" clId="{3333E839-D124-48EC-B15A-828897AF11B6}" dt="2021-10-22T08:20:19.511" v="267" actId="478"/>
          <ac:spMkLst>
            <pc:docMk/>
            <pc:sldMk cId="345643746" sldId="259"/>
            <ac:spMk id="48" creationId="{00000000-0000-0000-0000-000000000000}"/>
          </ac:spMkLst>
        </pc:spChg>
        <pc:spChg chg="add mod">
          <ac:chgData name="juanmanuel.lozanog@um.es" userId="618ed11e-cb2c-4b03-8ac9-a8cf52f924c9" providerId="ADAL" clId="{3333E839-D124-48EC-B15A-828897AF11B6}" dt="2021-10-22T08:18:03.006" v="233" actId="1076"/>
          <ac:spMkLst>
            <pc:docMk/>
            <pc:sldMk cId="345643746" sldId="259"/>
            <ac:spMk id="49" creationId="{024437EC-E7D3-4C28-8C34-005B5AFBC79D}"/>
          </ac:spMkLst>
        </pc:spChg>
        <pc:spChg chg="mod topLvl">
          <ac:chgData name="juanmanuel.lozanog@um.es" userId="618ed11e-cb2c-4b03-8ac9-a8cf52f924c9" providerId="ADAL" clId="{3333E839-D124-48EC-B15A-828897AF11B6}" dt="2021-10-22T08:17:33.372" v="229" actId="164"/>
          <ac:spMkLst>
            <pc:docMk/>
            <pc:sldMk cId="345643746" sldId="259"/>
            <ac:spMk id="51" creationId="{00000000-0000-0000-0000-000000000000}"/>
          </ac:spMkLst>
        </pc:spChg>
        <pc:spChg chg="add mod">
          <ac:chgData name="juanmanuel.lozanog@um.es" userId="618ed11e-cb2c-4b03-8ac9-a8cf52f924c9" providerId="ADAL" clId="{3333E839-D124-48EC-B15A-828897AF11B6}" dt="2021-10-22T08:20:41.093" v="269" actId="1076"/>
          <ac:spMkLst>
            <pc:docMk/>
            <pc:sldMk cId="345643746" sldId="259"/>
            <ac:spMk id="52" creationId="{F86CE4E0-925D-456D-B291-F81BFCF6FFE4}"/>
          </ac:spMkLst>
        </pc:spChg>
        <pc:spChg chg="mod topLvl">
          <ac:chgData name="juanmanuel.lozanog@um.es" userId="618ed11e-cb2c-4b03-8ac9-a8cf52f924c9" providerId="ADAL" clId="{3333E839-D124-48EC-B15A-828897AF11B6}" dt="2021-10-22T08:10:29.591" v="187" actId="165"/>
          <ac:spMkLst>
            <pc:docMk/>
            <pc:sldMk cId="345643746" sldId="259"/>
            <ac:spMk id="68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0:29.591" v="187" actId="165"/>
          <ac:spMkLst>
            <pc:docMk/>
            <pc:sldMk cId="345643746" sldId="259"/>
            <ac:spMk id="69" creationId="{00000000-0000-0000-0000-000000000000}"/>
          </ac:spMkLst>
        </pc:spChg>
        <pc:spChg chg="mod topLvl">
          <ac:chgData name="juanmanuel.lozanog@um.es" userId="618ed11e-cb2c-4b03-8ac9-a8cf52f924c9" providerId="ADAL" clId="{3333E839-D124-48EC-B15A-828897AF11B6}" dt="2021-10-22T08:10:29.591" v="187" actId="165"/>
          <ac:spMkLst>
            <pc:docMk/>
            <pc:sldMk cId="345643746" sldId="259"/>
            <ac:spMk id="70" creationId="{00000000-0000-0000-0000-000000000000}"/>
          </ac:spMkLst>
        </pc:spChg>
        <pc:grpChg chg="add mod">
          <ac:chgData name="juanmanuel.lozanog@um.es" userId="618ed11e-cb2c-4b03-8ac9-a8cf52f924c9" providerId="ADAL" clId="{3333E839-D124-48EC-B15A-828897AF11B6}" dt="2021-10-22T08:17:35.887" v="230" actId="1076"/>
          <ac:grpSpMkLst>
            <pc:docMk/>
            <pc:sldMk cId="345643746" sldId="259"/>
            <ac:grpSpMk id="6" creationId="{9C2B647F-DA53-417B-BDEC-11312B288338}"/>
          </ac:grpSpMkLst>
        </pc:grpChg>
        <pc:grpChg chg="del">
          <ac:chgData name="juanmanuel.lozanog@um.es" userId="618ed11e-cb2c-4b03-8ac9-a8cf52f924c9" providerId="ADAL" clId="{3333E839-D124-48EC-B15A-828897AF11B6}" dt="2021-10-22T08:10:29.591" v="187" actId="165"/>
          <ac:grpSpMkLst>
            <pc:docMk/>
            <pc:sldMk cId="345643746" sldId="259"/>
            <ac:grpSpMk id="25" creationId="{6ED0DA7D-5BDF-4004-8DED-F89FE6122690}"/>
          </ac:grpSpMkLst>
        </pc:grpChg>
        <pc:grpChg chg="del mod topLvl">
          <ac:chgData name="juanmanuel.lozanog@um.es" userId="618ed11e-cb2c-4b03-8ac9-a8cf52f924c9" providerId="ADAL" clId="{3333E839-D124-48EC-B15A-828897AF11B6}" dt="2021-10-22T08:17:15.625" v="225" actId="165"/>
          <ac:grpSpMkLst>
            <pc:docMk/>
            <pc:sldMk cId="345643746" sldId="259"/>
            <ac:grpSpMk id="53" creationId="{EC8F92F4-B53B-4BD2-910B-9AC1D666B977}"/>
          </ac:grpSpMkLst>
        </pc:grpChg>
        <pc:grpChg chg="del">
          <ac:chgData name="juanmanuel.lozanog@um.es" userId="618ed11e-cb2c-4b03-8ac9-a8cf52f924c9" providerId="ADAL" clId="{3333E839-D124-48EC-B15A-828897AF11B6}" dt="2021-10-22T08:10:16.344" v="185" actId="165"/>
          <ac:grpSpMkLst>
            <pc:docMk/>
            <pc:sldMk cId="345643746" sldId="259"/>
            <ac:grpSpMk id="54" creationId="{845EE6F5-DE17-4D3C-B6A8-1DA03845F472}"/>
          </ac:grpSpMkLst>
        </pc:grpChg>
        <pc:picChg chg="add mod modCrop">
          <ac:chgData name="juanmanuel.lozanog@um.es" userId="618ed11e-cb2c-4b03-8ac9-a8cf52f924c9" providerId="ADAL" clId="{3333E839-D124-48EC-B15A-828897AF11B6}" dt="2021-10-22T08:17:33.372" v="229" actId="164"/>
          <ac:picMkLst>
            <pc:docMk/>
            <pc:sldMk cId="345643746" sldId="259"/>
            <ac:picMk id="3" creationId="{9C1B281F-F862-43C1-9F2F-EB67C9280265}"/>
          </ac:picMkLst>
        </pc:picChg>
        <pc:picChg chg="add mod modCrop">
          <ac:chgData name="juanmanuel.lozanog@um.es" userId="618ed11e-cb2c-4b03-8ac9-a8cf52f924c9" providerId="ADAL" clId="{3333E839-D124-48EC-B15A-828897AF11B6}" dt="2021-10-22T08:17:33.372" v="229" actId="164"/>
          <ac:picMkLst>
            <pc:docMk/>
            <pc:sldMk cId="345643746" sldId="259"/>
            <ac:picMk id="5" creationId="{2B3586A7-69D5-48A7-8342-AE196FA7B866}"/>
          </ac:picMkLst>
        </pc:picChg>
        <pc:picChg chg="add mod modCrop">
          <ac:chgData name="juanmanuel.lozanog@um.es" userId="618ed11e-cb2c-4b03-8ac9-a8cf52f924c9" providerId="ADAL" clId="{3333E839-D124-48EC-B15A-828897AF11B6}" dt="2021-10-22T08:19:31.958" v="255" actId="1076"/>
          <ac:picMkLst>
            <pc:docMk/>
            <pc:sldMk cId="345643746" sldId="259"/>
            <ac:picMk id="9" creationId="{3B479F98-5413-494A-B6A2-B86973DC3A59}"/>
          </ac:picMkLst>
        </pc:picChg>
        <pc:picChg chg="add mod modCrop">
          <ac:chgData name="juanmanuel.lozanog@um.es" userId="618ed11e-cb2c-4b03-8ac9-a8cf52f924c9" providerId="ADAL" clId="{3333E839-D124-48EC-B15A-828897AF11B6}" dt="2021-10-22T08:19:31.958" v="255" actId="1076"/>
          <ac:picMkLst>
            <pc:docMk/>
            <pc:sldMk cId="345643746" sldId="259"/>
            <ac:picMk id="11" creationId="{B0AD7750-A493-41F6-BBAB-BC78BF72137C}"/>
          </ac:picMkLst>
        </pc:picChg>
        <pc:picChg chg="del mod topLvl">
          <ac:chgData name="juanmanuel.lozanog@um.es" userId="618ed11e-cb2c-4b03-8ac9-a8cf52f924c9" providerId="ADAL" clId="{3333E839-D124-48EC-B15A-828897AF11B6}" dt="2021-10-22T08:10:33.153" v="188" actId="478"/>
          <ac:picMkLst>
            <pc:docMk/>
            <pc:sldMk cId="345643746" sldId="259"/>
            <ac:picMk id="13" creationId="{DB8E88D5-8447-4D32-BF8E-150AD87F0332}"/>
          </ac:picMkLst>
        </pc:picChg>
        <pc:picChg chg="mod">
          <ac:chgData name="juanmanuel.lozanog@um.es" userId="618ed11e-cb2c-4b03-8ac9-a8cf52f924c9" providerId="ADAL" clId="{3333E839-D124-48EC-B15A-828897AF11B6}" dt="2021-10-22T08:19:56.953" v="262" actId="1076"/>
          <ac:picMkLst>
            <pc:docMk/>
            <pc:sldMk cId="345643746" sldId="259"/>
            <ac:picMk id="19" creationId="{00000000-0000-0000-0000-000000000000}"/>
          </ac:picMkLst>
        </pc:picChg>
        <pc:picChg chg="del mod topLvl">
          <ac:chgData name="juanmanuel.lozanog@um.es" userId="618ed11e-cb2c-4b03-8ac9-a8cf52f924c9" providerId="ADAL" clId="{3333E839-D124-48EC-B15A-828897AF11B6}" dt="2021-10-22T08:10:33.153" v="188" actId="478"/>
          <ac:picMkLst>
            <pc:docMk/>
            <pc:sldMk cId="345643746" sldId="259"/>
            <ac:picMk id="20" creationId="{0C5B36B1-1D10-4E3D-925F-E988B26B4120}"/>
          </ac:picMkLst>
        </pc:picChg>
        <pc:picChg chg="del mod">
          <ac:chgData name="juanmanuel.lozanog@um.es" userId="618ed11e-cb2c-4b03-8ac9-a8cf52f924c9" providerId="ADAL" clId="{3333E839-D124-48EC-B15A-828897AF11B6}" dt="2021-10-22T08:10:24.093" v="186" actId="21"/>
          <ac:picMkLst>
            <pc:docMk/>
            <pc:sldMk cId="345643746" sldId="259"/>
            <ac:picMk id="22" creationId="{C76D44F0-4954-4CD4-B398-2636551F6F67}"/>
          </ac:picMkLst>
        </pc:picChg>
        <pc:picChg chg="del mod">
          <ac:chgData name="juanmanuel.lozanog@um.es" userId="618ed11e-cb2c-4b03-8ac9-a8cf52f924c9" providerId="ADAL" clId="{3333E839-D124-48EC-B15A-828897AF11B6}" dt="2021-10-22T08:10:24.093" v="186" actId="21"/>
          <ac:picMkLst>
            <pc:docMk/>
            <pc:sldMk cId="345643746" sldId="259"/>
            <ac:picMk id="24" creationId="{EE06E885-0E3A-4AC3-A8B1-5E16D228F4B9}"/>
          </ac:picMkLst>
        </pc:picChg>
      </pc:sldChg>
      <pc:sldChg chg="del">
        <pc:chgData name="juanmanuel.lozanog@um.es" userId="618ed11e-cb2c-4b03-8ac9-a8cf52f924c9" providerId="ADAL" clId="{3333E839-D124-48EC-B15A-828897AF11B6}" dt="2021-10-22T08:03:22.358" v="27" actId="47"/>
        <pc:sldMkLst>
          <pc:docMk/>
          <pc:sldMk cId="901017724" sldId="259"/>
        </pc:sldMkLst>
      </pc:sldChg>
      <pc:sldChg chg="del">
        <pc:chgData name="juanmanuel.lozanog@um.es" userId="618ed11e-cb2c-4b03-8ac9-a8cf52f924c9" providerId="ADAL" clId="{3333E839-D124-48EC-B15A-828897AF11B6}" dt="2021-10-22T08:02:49.067" v="2" actId="47"/>
        <pc:sldMkLst>
          <pc:docMk/>
          <pc:sldMk cId="355203708" sldId="260"/>
        </pc:sldMkLst>
      </pc:sldChg>
    </pc:docChg>
  </pc:docChgLst>
  <pc:docChgLst>
    <pc:chgData name="juanmanuel.lozanog@um.es" userId="618ed11e-cb2c-4b03-8ac9-a8cf52f924c9" providerId="ADAL" clId="{60BB7EE5-8B09-4526-B29B-BA167EE2FBDB}"/>
    <pc:docChg chg="undo custSel modSld">
      <pc:chgData name="juanmanuel.lozanog@um.es" userId="618ed11e-cb2c-4b03-8ac9-a8cf52f924c9" providerId="ADAL" clId="{60BB7EE5-8B09-4526-B29B-BA167EE2FBDB}" dt="2021-11-08T08:46:54.499" v="6" actId="1076"/>
      <pc:docMkLst>
        <pc:docMk/>
      </pc:docMkLst>
      <pc:sldChg chg="modSp mod">
        <pc:chgData name="juanmanuel.lozanog@um.es" userId="618ed11e-cb2c-4b03-8ac9-a8cf52f924c9" providerId="ADAL" clId="{60BB7EE5-8B09-4526-B29B-BA167EE2FBDB}" dt="2021-11-08T08:46:54.499" v="6" actId="1076"/>
        <pc:sldMkLst>
          <pc:docMk/>
          <pc:sldMk cId="301756167" sldId="258"/>
        </pc:sldMkLst>
        <pc:spChg chg="mod">
          <ac:chgData name="juanmanuel.lozanog@um.es" userId="618ed11e-cb2c-4b03-8ac9-a8cf52f924c9" providerId="ADAL" clId="{60BB7EE5-8B09-4526-B29B-BA167EE2FBDB}" dt="2021-11-08T08:46:54.499" v="6" actId="1076"/>
          <ac:spMkLst>
            <pc:docMk/>
            <pc:sldMk cId="301756167" sldId="258"/>
            <ac:spMk id="45" creationId="{00000000-0000-0000-0000-000000000000}"/>
          </ac:spMkLst>
        </pc:spChg>
        <pc:picChg chg="mod">
          <ac:chgData name="juanmanuel.lozanog@um.es" userId="618ed11e-cb2c-4b03-8ac9-a8cf52f924c9" providerId="ADAL" clId="{60BB7EE5-8B09-4526-B29B-BA167EE2FBDB}" dt="2021-11-08T08:46:46.078" v="1" actId="1076"/>
          <ac:picMkLst>
            <pc:docMk/>
            <pc:sldMk cId="301756167" sldId="258"/>
            <ac:picMk id="19" creationId="{00000000-0000-0000-0000-000000000000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F6388-0D86-6C45-9788-E3DA49C438EC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9158EC-BEAA-D645-B7D4-F2799FF68E79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677342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_tradnl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39158EC-BEAA-D645-B7D4-F2799FF68E79}" type="slidenum">
              <a:rPr lang="es-ES_tradnl" smtClean="0"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2818956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_tradnl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_tradnl"/>
              <a:t>Arrastre la imagen al marcador de posición o haga clic en el icono para agrega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_tradnl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los estilos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239D0-559F-934E-BFD2-5DDBDDB92B5B}" type="datetimeFigureOut">
              <a:rPr lang="es-ES_tradnl" smtClean="0"/>
              <a:t>19/07/2023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DC9FEF-32CA-CD44-A817-96A7BCA1A2BD}" type="slidenum">
              <a:rPr lang="es-ES_tradnl" smtClean="0"/>
              <a:t>‹Nº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1880288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jp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Agrupar 3"/>
          <p:cNvGrpSpPr/>
          <p:nvPr/>
        </p:nvGrpSpPr>
        <p:grpSpPr>
          <a:xfrm>
            <a:off x="217652" y="2521370"/>
            <a:ext cx="3086888" cy="3044207"/>
            <a:chOff x="280046" y="1917369"/>
            <a:chExt cx="3086888" cy="3044207"/>
          </a:xfrm>
        </p:grpSpPr>
        <p:sp>
          <p:nvSpPr>
            <p:cNvPr id="36" name="CuadroTexto 35">
              <a:extLst>
                <a:ext uri="{FF2B5EF4-FFF2-40B4-BE49-F238E27FC236}">
                  <a16:creationId xmlns:a16="http://schemas.microsoft.com/office/drawing/2014/main" id="{024437EC-E7D3-4C28-8C34-005B5AFBC79D}"/>
                </a:ext>
              </a:extLst>
            </p:cNvPr>
            <p:cNvSpPr txBox="1"/>
            <p:nvPr/>
          </p:nvSpPr>
          <p:spPr>
            <a:xfrm>
              <a:off x="2927390" y="2917821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_tradnl" sz="1200" b="1" dirty="0"/>
                <a:t>FLII </a:t>
              </a:r>
            </a:p>
          </p:txBody>
        </p:sp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5000" contrast="-3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805" t="27250" r="66987" b="19430"/>
            <a:stretch/>
          </p:blipFill>
          <p:spPr>
            <a:xfrm>
              <a:off x="931183" y="1917369"/>
              <a:ext cx="250998" cy="30404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" name="Imagen 2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013" t="27250" r="43244" b="19430"/>
            <a:stretch/>
          </p:blipFill>
          <p:spPr>
            <a:xfrm>
              <a:off x="1346631" y="1921128"/>
              <a:ext cx="1416309" cy="304044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9" name="CuadroTexto 38"/>
            <p:cNvSpPr txBox="1"/>
            <p:nvPr/>
          </p:nvSpPr>
          <p:spPr>
            <a:xfrm>
              <a:off x="280046" y="2139228"/>
              <a:ext cx="5998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182kDa</a:t>
              </a:r>
            </a:p>
          </p:txBody>
        </p:sp>
        <p:sp>
          <p:nvSpPr>
            <p:cNvPr id="49" name="CuadroTexto 48"/>
            <p:cNvSpPr txBox="1"/>
            <p:nvPr/>
          </p:nvSpPr>
          <p:spPr>
            <a:xfrm>
              <a:off x="282857" y="2443501"/>
              <a:ext cx="59984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116kDa</a:t>
              </a:r>
            </a:p>
          </p:txBody>
        </p:sp>
        <p:sp>
          <p:nvSpPr>
            <p:cNvPr id="52" name="CuadroTexto 51"/>
            <p:cNvSpPr txBox="1"/>
            <p:nvPr/>
          </p:nvSpPr>
          <p:spPr>
            <a:xfrm>
              <a:off x="314510" y="2823198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82kDa</a:t>
              </a:r>
            </a:p>
          </p:txBody>
        </p:sp>
        <p:sp>
          <p:nvSpPr>
            <p:cNvPr id="55" name="CuadroTexto 54"/>
            <p:cNvSpPr txBox="1"/>
            <p:nvPr/>
          </p:nvSpPr>
          <p:spPr>
            <a:xfrm>
              <a:off x="305538" y="3248418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64kDa</a:t>
              </a:r>
            </a:p>
          </p:txBody>
        </p:sp>
        <p:sp>
          <p:nvSpPr>
            <p:cNvPr id="56" name="CuadroTexto 55"/>
            <p:cNvSpPr txBox="1"/>
            <p:nvPr/>
          </p:nvSpPr>
          <p:spPr>
            <a:xfrm>
              <a:off x="314510" y="3600158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 dirty="0"/>
                <a:t>49kDa</a:t>
              </a:r>
            </a:p>
          </p:txBody>
        </p:sp>
        <p:sp>
          <p:nvSpPr>
            <p:cNvPr id="57" name="CuadroTexto 56"/>
            <p:cNvSpPr txBox="1"/>
            <p:nvPr/>
          </p:nvSpPr>
          <p:spPr>
            <a:xfrm>
              <a:off x="305454" y="3963716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_tradnl" sz="1050"/>
                <a:t>37kDa</a:t>
              </a:r>
              <a:endParaRPr lang="es-ES_tradnl" sz="1050" dirty="0"/>
            </a:p>
          </p:txBody>
        </p:sp>
      </p:grpSp>
      <p:sp>
        <p:nvSpPr>
          <p:cNvPr id="59" name="CuadroTexto 58"/>
          <p:cNvSpPr txBox="1"/>
          <p:nvPr/>
        </p:nvSpPr>
        <p:spPr>
          <a:xfrm rot="16200000">
            <a:off x="1107786" y="1833664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NPUT</a:t>
            </a:r>
          </a:p>
        </p:txBody>
      </p:sp>
      <p:sp>
        <p:nvSpPr>
          <p:cNvPr id="60" name="CuadroTexto 59"/>
          <p:cNvSpPr txBox="1"/>
          <p:nvPr/>
        </p:nvSpPr>
        <p:spPr>
          <a:xfrm rot="16200000">
            <a:off x="2040290" y="1795265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FLII</a:t>
            </a:r>
          </a:p>
        </p:txBody>
      </p:sp>
      <p:sp>
        <p:nvSpPr>
          <p:cNvPr id="61" name="CuadroTexto 60"/>
          <p:cNvSpPr txBox="1"/>
          <p:nvPr/>
        </p:nvSpPr>
        <p:spPr>
          <a:xfrm rot="16200000">
            <a:off x="1542734" y="1855305"/>
            <a:ext cx="72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</a:t>
            </a:r>
            <a:r>
              <a:rPr lang="es-ES_tradnl" dirty="0" err="1"/>
              <a:t>IgG</a:t>
            </a:r>
            <a:endParaRPr lang="es-ES_tradnl" dirty="0"/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id="{61828227-3706-FF1F-DBF2-0338C19D7B62}"/>
              </a:ext>
            </a:extLst>
          </p:cNvPr>
          <p:cNvSpPr/>
          <p:nvPr/>
        </p:nvSpPr>
        <p:spPr>
          <a:xfrm>
            <a:off x="1205545" y="2812479"/>
            <a:ext cx="1550593" cy="3693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17561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Agrupar 6">
            <a:extLst>
              <a:ext uri="{FF2B5EF4-FFF2-40B4-BE49-F238E27FC236}">
                <a16:creationId xmlns:a16="http://schemas.microsoft.com/office/drawing/2014/main" id="{786686AA-98AB-A46F-C92B-C3CF5DC6755A}"/>
              </a:ext>
            </a:extLst>
          </p:cNvPr>
          <p:cNvGrpSpPr/>
          <p:nvPr/>
        </p:nvGrpSpPr>
        <p:grpSpPr>
          <a:xfrm>
            <a:off x="3171461" y="1683955"/>
            <a:ext cx="3424266" cy="3839481"/>
            <a:chOff x="4773028" y="1588084"/>
            <a:chExt cx="3424266" cy="3839481"/>
          </a:xfrm>
        </p:grpSpPr>
        <p:grpSp>
          <p:nvGrpSpPr>
            <p:cNvPr id="5" name="Grupo 4">
              <a:extLst>
                <a:ext uri="{FF2B5EF4-FFF2-40B4-BE49-F238E27FC236}">
                  <a16:creationId xmlns:a16="http://schemas.microsoft.com/office/drawing/2014/main" id="{1365B62F-5D5F-59D8-205A-8E76AFD7F429}"/>
                </a:ext>
              </a:extLst>
            </p:cNvPr>
            <p:cNvGrpSpPr/>
            <p:nvPr/>
          </p:nvGrpSpPr>
          <p:grpSpPr>
            <a:xfrm>
              <a:off x="4773028" y="1588084"/>
              <a:ext cx="3424266" cy="3121378"/>
              <a:chOff x="5765120" y="1585663"/>
              <a:chExt cx="3424266" cy="3121378"/>
            </a:xfrm>
          </p:grpSpPr>
          <p:sp>
            <p:nvSpPr>
              <p:cNvPr id="8" name="CuadroTexto 7">
                <a:extLst>
                  <a:ext uri="{FF2B5EF4-FFF2-40B4-BE49-F238E27FC236}">
                    <a16:creationId xmlns:a16="http://schemas.microsoft.com/office/drawing/2014/main" id="{F62F7BDF-9647-C386-8F4F-43C38B6B74EB}"/>
                  </a:ext>
                </a:extLst>
              </p:cNvPr>
              <p:cNvSpPr txBox="1"/>
              <p:nvPr/>
            </p:nvSpPr>
            <p:spPr>
              <a:xfrm rot="16200000">
                <a:off x="6660616" y="1829974"/>
                <a:ext cx="76976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dirty="0"/>
                  <a:t>INPUT</a:t>
                </a:r>
              </a:p>
            </p:txBody>
          </p:sp>
          <p:sp>
            <p:nvSpPr>
              <p:cNvPr id="9" name="CuadroTexto 8">
                <a:extLst>
                  <a:ext uri="{FF2B5EF4-FFF2-40B4-BE49-F238E27FC236}">
                    <a16:creationId xmlns:a16="http://schemas.microsoft.com/office/drawing/2014/main" id="{7D713267-C6E3-2679-D6AE-16F2C396047F}"/>
                  </a:ext>
                </a:extLst>
              </p:cNvPr>
              <p:cNvSpPr txBox="1"/>
              <p:nvPr/>
            </p:nvSpPr>
            <p:spPr>
              <a:xfrm rot="16200000">
                <a:off x="7600228" y="1767444"/>
                <a:ext cx="73289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dirty="0"/>
                  <a:t>IP FLII</a:t>
                </a:r>
              </a:p>
            </p:txBody>
          </p:sp>
          <p:sp>
            <p:nvSpPr>
              <p:cNvPr id="10" name="CuadroTexto 9">
                <a:extLst>
                  <a:ext uri="{FF2B5EF4-FFF2-40B4-BE49-F238E27FC236}">
                    <a16:creationId xmlns:a16="http://schemas.microsoft.com/office/drawing/2014/main" id="{13B1E4A4-DB0D-5B2B-C24B-CBDB7476B17E}"/>
                  </a:ext>
                </a:extLst>
              </p:cNvPr>
              <p:cNvSpPr txBox="1"/>
              <p:nvPr/>
            </p:nvSpPr>
            <p:spPr>
              <a:xfrm rot="16200000">
                <a:off x="7095564" y="1829974"/>
                <a:ext cx="72648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dirty="0"/>
                  <a:t>IP </a:t>
                </a:r>
                <a:r>
                  <a:rPr lang="es-ES_tradnl" dirty="0" err="1"/>
                  <a:t>IgG</a:t>
                </a:r>
                <a:endParaRPr lang="es-ES_tradnl" dirty="0"/>
              </a:p>
            </p:txBody>
          </p:sp>
          <p:sp>
            <p:nvSpPr>
              <p:cNvPr id="11" name="CuadroTexto 10">
                <a:extLst>
                  <a:ext uri="{FF2B5EF4-FFF2-40B4-BE49-F238E27FC236}">
                    <a16:creationId xmlns:a16="http://schemas.microsoft.com/office/drawing/2014/main" id="{F0185F5E-E877-53D3-A1F1-FC0B42BE1CD2}"/>
                  </a:ext>
                </a:extLst>
              </p:cNvPr>
              <p:cNvSpPr txBox="1"/>
              <p:nvPr/>
            </p:nvSpPr>
            <p:spPr>
              <a:xfrm>
                <a:off x="5765120" y="2612430"/>
                <a:ext cx="5998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50" dirty="0"/>
                  <a:t>182kDa</a:t>
                </a:r>
              </a:p>
            </p:txBody>
          </p:sp>
          <p:sp>
            <p:nvSpPr>
              <p:cNvPr id="12" name="CuadroTexto 11">
                <a:extLst>
                  <a:ext uri="{FF2B5EF4-FFF2-40B4-BE49-F238E27FC236}">
                    <a16:creationId xmlns:a16="http://schemas.microsoft.com/office/drawing/2014/main" id="{62AAE0C8-815E-D22B-F1ED-1FF27FF0A699}"/>
                  </a:ext>
                </a:extLst>
              </p:cNvPr>
              <p:cNvSpPr txBox="1"/>
              <p:nvPr/>
            </p:nvSpPr>
            <p:spPr>
              <a:xfrm>
                <a:off x="5779354" y="2952549"/>
                <a:ext cx="5998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50" dirty="0"/>
                  <a:t>116kDa</a:t>
                </a:r>
              </a:p>
            </p:txBody>
          </p:sp>
          <p:sp>
            <p:nvSpPr>
              <p:cNvPr id="13" name="CuadroTexto 12">
                <a:extLst>
                  <a:ext uri="{FF2B5EF4-FFF2-40B4-BE49-F238E27FC236}">
                    <a16:creationId xmlns:a16="http://schemas.microsoft.com/office/drawing/2014/main" id="{BD92DB75-7EDF-9C75-1D81-B34ADA528BF4}"/>
                  </a:ext>
                </a:extLst>
              </p:cNvPr>
              <p:cNvSpPr txBox="1"/>
              <p:nvPr/>
            </p:nvSpPr>
            <p:spPr>
              <a:xfrm>
                <a:off x="5834049" y="3214509"/>
                <a:ext cx="53091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50" dirty="0"/>
                  <a:t>82kDa</a:t>
                </a:r>
              </a:p>
            </p:txBody>
          </p:sp>
          <p:sp>
            <p:nvSpPr>
              <p:cNvPr id="14" name="CuadroTexto 13">
                <a:extLst>
                  <a:ext uri="{FF2B5EF4-FFF2-40B4-BE49-F238E27FC236}">
                    <a16:creationId xmlns:a16="http://schemas.microsoft.com/office/drawing/2014/main" id="{19D17294-921B-3F28-C6DC-7CBCC42FCA96}"/>
                  </a:ext>
                </a:extLst>
              </p:cNvPr>
              <p:cNvSpPr txBox="1"/>
              <p:nvPr/>
            </p:nvSpPr>
            <p:spPr>
              <a:xfrm>
                <a:off x="5820707" y="3639358"/>
                <a:ext cx="53091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50" dirty="0"/>
                  <a:t>64kDa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:a16="http://schemas.microsoft.com/office/drawing/2014/main" id="{17393FC0-0DA0-2DD1-971A-C1F399B8830B}"/>
                  </a:ext>
                </a:extLst>
              </p:cNvPr>
              <p:cNvSpPr txBox="1"/>
              <p:nvPr/>
            </p:nvSpPr>
            <p:spPr>
              <a:xfrm>
                <a:off x="5837830" y="4059533"/>
                <a:ext cx="53091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50" dirty="0"/>
                  <a:t>49kDa</a:t>
                </a:r>
              </a:p>
            </p:txBody>
          </p:sp>
          <p:sp>
            <p:nvSpPr>
              <p:cNvPr id="16" name="CuadroTexto 15">
                <a:extLst>
                  <a:ext uri="{FF2B5EF4-FFF2-40B4-BE49-F238E27FC236}">
                    <a16:creationId xmlns:a16="http://schemas.microsoft.com/office/drawing/2014/main" id="{9D1A6F9F-05CE-68E0-2570-EBB14900009E}"/>
                  </a:ext>
                </a:extLst>
              </p:cNvPr>
              <p:cNvSpPr txBox="1"/>
              <p:nvPr/>
            </p:nvSpPr>
            <p:spPr>
              <a:xfrm>
                <a:off x="5868364" y="4453125"/>
                <a:ext cx="53091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_tradnl" sz="1050"/>
                  <a:t>37kDa</a:t>
                </a:r>
                <a:endParaRPr lang="es-ES_tradnl" sz="1050" dirty="0"/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:a16="http://schemas.microsoft.com/office/drawing/2014/main" id="{0435A58E-B10F-C069-70F7-C436B93D1D84}"/>
                  </a:ext>
                </a:extLst>
              </p:cNvPr>
              <p:cNvSpPr txBox="1"/>
              <p:nvPr/>
            </p:nvSpPr>
            <p:spPr>
              <a:xfrm>
                <a:off x="8591145" y="3540160"/>
                <a:ext cx="5982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_tradnl" sz="1200" b="1" dirty="0"/>
                  <a:t>NLRP1</a:t>
                </a:r>
              </a:p>
            </p:txBody>
          </p:sp>
        </p:grpSp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84836211-D43E-BE30-D6D8-D374F8B22C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98" t="21494" r="40194" b="25906"/>
            <a:stretch/>
          </p:blipFill>
          <p:spPr>
            <a:xfrm>
              <a:off x="5829049" y="2472832"/>
              <a:ext cx="1344297" cy="29547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Imagen 6">
              <a:extLst>
                <a:ext uri="{FF2B5EF4-FFF2-40B4-BE49-F238E27FC236}">
                  <a16:creationId xmlns:a16="http://schemas.microsoft.com/office/drawing/2014/main" id="{BA7E2C23-A214-C20F-2E7C-296E93B050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280" t="22717" r="63619" b="25466"/>
            <a:stretch/>
          </p:blipFill>
          <p:spPr>
            <a:xfrm>
              <a:off x="5396343" y="2472832"/>
              <a:ext cx="298040" cy="295473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18" name="Rectángulo 17">
            <a:extLst>
              <a:ext uri="{FF2B5EF4-FFF2-40B4-BE49-F238E27FC236}">
                <a16:creationId xmlns:a16="http://schemas.microsoft.com/office/drawing/2014/main" id="{065D67CC-B73D-B1D7-886C-58B3F3DDDB04}"/>
              </a:ext>
            </a:extLst>
          </p:cNvPr>
          <p:cNvSpPr/>
          <p:nvPr/>
        </p:nvSpPr>
        <p:spPr>
          <a:xfrm>
            <a:off x="4124333" y="2837680"/>
            <a:ext cx="1550593" cy="3693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27792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45FB7208-9B40-FE7F-69B2-9AAC01AC37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67" t="14386" r="43730" b="34298"/>
          <a:stretch/>
        </p:blipFill>
        <p:spPr>
          <a:xfrm>
            <a:off x="3109917" y="2576981"/>
            <a:ext cx="1423710" cy="299222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33211763-3679-17D4-5C16-ADE69298E7A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88" t="14385" r="65575" b="34299"/>
          <a:stretch/>
        </p:blipFill>
        <p:spPr>
          <a:xfrm>
            <a:off x="2639001" y="2576981"/>
            <a:ext cx="371815" cy="29922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1E1F6B9D-CD70-9735-2F43-96974DD847FB}"/>
              </a:ext>
            </a:extLst>
          </p:cNvPr>
          <p:cNvSpPr txBox="1"/>
          <p:nvPr/>
        </p:nvSpPr>
        <p:spPr>
          <a:xfrm rot="16200000">
            <a:off x="2948450" y="194831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NPUT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40B2E6C7-69D5-0BFC-1183-E87CFFEC27F2}"/>
              </a:ext>
            </a:extLst>
          </p:cNvPr>
          <p:cNvSpPr txBox="1"/>
          <p:nvPr/>
        </p:nvSpPr>
        <p:spPr>
          <a:xfrm rot="16200000">
            <a:off x="3888062" y="1885781"/>
            <a:ext cx="7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FLII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7139F126-7686-7123-4E8D-CEB4F0ABABD7}"/>
              </a:ext>
            </a:extLst>
          </p:cNvPr>
          <p:cNvSpPr txBox="1"/>
          <p:nvPr/>
        </p:nvSpPr>
        <p:spPr>
          <a:xfrm rot="16200000">
            <a:off x="3383398" y="1948311"/>
            <a:ext cx="72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dirty="0"/>
              <a:t>IP </a:t>
            </a:r>
            <a:r>
              <a:rPr lang="es-ES_tradnl" dirty="0" err="1"/>
              <a:t>IgG</a:t>
            </a:r>
            <a:endParaRPr lang="es-ES_tradnl" dirty="0"/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BD889C90-6099-F044-C490-45FB504063DA}"/>
              </a:ext>
            </a:extLst>
          </p:cNvPr>
          <p:cNvSpPr txBox="1"/>
          <p:nvPr/>
        </p:nvSpPr>
        <p:spPr>
          <a:xfrm>
            <a:off x="1995939" y="2705005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82kDa</a:t>
            </a: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801AFF1C-455D-87D6-3BB6-99CF7D5CF06F}"/>
              </a:ext>
            </a:extLst>
          </p:cNvPr>
          <p:cNvSpPr txBox="1"/>
          <p:nvPr/>
        </p:nvSpPr>
        <p:spPr>
          <a:xfrm>
            <a:off x="2010173" y="3045124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116kDa</a:t>
            </a: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3C4EFD8F-5EE5-5DFB-D3A6-D4F547A2EC07}"/>
              </a:ext>
            </a:extLst>
          </p:cNvPr>
          <p:cNvSpPr txBox="1"/>
          <p:nvPr/>
        </p:nvSpPr>
        <p:spPr>
          <a:xfrm>
            <a:off x="2064868" y="3307084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82kDa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369B045C-4397-4E56-DDBA-FAC92649D100}"/>
              </a:ext>
            </a:extLst>
          </p:cNvPr>
          <p:cNvSpPr txBox="1"/>
          <p:nvPr/>
        </p:nvSpPr>
        <p:spPr>
          <a:xfrm>
            <a:off x="2051526" y="3731933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64kDa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75481FFD-AA47-7F77-26B4-37102DA56EE6}"/>
              </a:ext>
            </a:extLst>
          </p:cNvPr>
          <p:cNvSpPr txBox="1"/>
          <p:nvPr/>
        </p:nvSpPr>
        <p:spPr>
          <a:xfrm>
            <a:off x="2068649" y="4152108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 dirty="0"/>
              <a:t>49kDa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06D30F81-22A5-E58D-0EEB-C8CD7F58DAC8}"/>
              </a:ext>
            </a:extLst>
          </p:cNvPr>
          <p:cNvSpPr txBox="1"/>
          <p:nvPr/>
        </p:nvSpPr>
        <p:spPr>
          <a:xfrm>
            <a:off x="2099183" y="4545700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_tradnl" sz="1050"/>
              <a:t>37kDa</a:t>
            </a:r>
            <a:endParaRPr lang="es-ES_tradnl" sz="1050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C3A1FA44-5AB4-DA34-8050-F3D26B8AEF08}"/>
              </a:ext>
            </a:extLst>
          </p:cNvPr>
          <p:cNvSpPr txBox="1"/>
          <p:nvPr/>
        </p:nvSpPr>
        <p:spPr>
          <a:xfrm>
            <a:off x="4926486" y="3566576"/>
            <a:ext cx="696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_tradnl" sz="1200" b="1" dirty="0"/>
              <a:t>LRRFIP1</a:t>
            </a:r>
            <a:endParaRPr lang="mr-IN" sz="1200" b="1" dirty="0"/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id="{8147D8DC-4C5A-F2B2-6227-C33C93F82EDA}"/>
              </a:ext>
            </a:extLst>
          </p:cNvPr>
          <p:cNvSpPr/>
          <p:nvPr/>
        </p:nvSpPr>
        <p:spPr>
          <a:xfrm>
            <a:off x="3050253" y="2696373"/>
            <a:ext cx="1550593" cy="36933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105212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5</TotalTime>
  <Words>37</Words>
  <Application>Microsoft Office PowerPoint</Application>
  <PresentationFormat>Presentación en pantalla (4:3)</PresentationFormat>
  <Paragraphs>31</Paragraphs>
  <Slides>3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anm.lozanogil@outlook.com</dc:creator>
  <cp:lastModifiedBy>JUAN MANUEL LOZANO GIL</cp:lastModifiedBy>
  <cp:revision>28</cp:revision>
  <dcterms:created xsi:type="dcterms:W3CDTF">2021-02-12T15:49:09Z</dcterms:created>
  <dcterms:modified xsi:type="dcterms:W3CDTF">2023-07-19T09:51:48Z</dcterms:modified>
</cp:coreProperties>
</file>